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5" r:id="rId2"/>
    <p:sldId id="272" r:id="rId3"/>
    <p:sldId id="273" r:id="rId4"/>
    <p:sldId id="271" r:id="rId5"/>
    <p:sldId id="274" r:id="rId6"/>
  </p:sldIdLst>
  <p:sldSz cx="7553325" cy="1043305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86">
          <p15:clr>
            <a:srgbClr val="A4A3A4"/>
          </p15:clr>
        </p15:guide>
        <p15:guide id="2" pos="237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595" autoAdjust="0"/>
    <p:restoredTop sz="94495"/>
  </p:normalViewPr>
  <p:slideViewPr>
    <p:cSldViewPr>
      <p:cViewPr>
        <p:scale>
          <a:sx n="68" d="100"/>
          <a:sy n="68" d="100"/>
        </p:scale>
        <p:origin x="1500" y="-804"/>
      </p:cViewPr>
      <p:guideLst>
        <p:guide orient="horz" pos="3286"/>
        <p:guide pos="237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54628E-252A-4FB5-8293-8710BC5AA3EC}" type="datetimeFigureOut">
              <a:rPr lang="en-US" smtClean="0"/>
              <a:t>9/1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85800"/>
            <a:ext cx="24828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A08EE7-4612-410D-8888-7CB28DDA7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488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500" y="3241008"/>
            <a:ext cx="6420326" cy="223634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2999" y="5912062"/>
            <a:ext cx="5287328" cy="266622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76161" y="417807"/>
            <a:ext cx="1699498" cy="89019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7666" y="417807"/>
            <a:ext cx="4972606" cy="89019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6661" y="6704201"/>
            <a:ext cx="6420326" cy="207212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6661" y="4421972"/>
            <a:ext cx="6420326" cy="228222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7666" y="2434379"/>
            <a:ext cx="3336052" cy="68853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9607" y="2434379"/>
            <a:ext cx="3336052" cy="68853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6" y="2335362"/>
            <a:ext cx="3337364" cy="97326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666" y="3308629"/>
            <a:ext cx="3337364" cy="60110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6984" y="2335362"/>
            <a:ext cx="3338675" cy="97326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6984" y="3308629"/>
            <a:ext cx="3338675" cy="60110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667" y="415390"/>
            <a:ext cx="2484992" cy="17678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3141" y="415391"/>
            <a:ext cx="4222518" cy="890431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667" y="2183213"/>
            <a:ext cx="2484992" cy="71364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0505" y="7303135"/>
            <a:ext cx="4531995" cy="86217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0505" y="932212"/>
            <a:ext cx="4531995" cy="625983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0505" y="8165311"/>
            <a:ext cx="4531995" cy="12244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7666" y="417806"/>
            <a:ext cx="6797993" cy="17388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6" y="2434379"/>
            <a:ext cx="6797993" cy="68853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666" y="9669893"/>
            <a:ext cx="1762443" cy="5554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0720" y="9669893"/>
            <a:ext cx="2391886" cy="5554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3216" y="9669893"/>
            <a:ext cx="1762443" cy="5554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-681" y="1480385"/>
            <a:ext cx="6803571" cy="6592033"/>
            <a:chOff x="21091" y="1177925"/>
            <a:chExt cx="6803571" cy="6592033"/>
          </a:xfrm>
        </p:grpSpPr>
        <p:grpSp>
          <p:nvGrpSpPr>
            <p:cNvPr id="8" name="Group 7"/>
            <p:cNvGrpSpPr/>
            <p:nvPr/>
          </p:nvGrpSpPr>
          <p:grpSpPr>
            <a:xfrm>
              <a:off x="21091" y="1177925"/>
              <a:ext cx="6528391" cy="6592033"/>
              <a:chOff x="21091" y="1177925"/>
              <a:chExt cx="6528391" cy="6592033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028" t="15069" r="31508" b="12361"/>
              <a:stretch/>
            </p:blipFill>
            <p:spPr>
              <a:xfrm>
                <a:off x="21091" y="1177925"/>
                <a:ext cx="6528391" cy="6592033"/>
              </a:xfrm>
              <a:prstGeom prst="rect">
                <a:avLst/>
              </a:prstGeom>
            </p:spPr>
          </p:pic>
          <p:sp>
            <p:nvSpPr>
              <p:cNvPr id="7" name="Rectangle 6"/>
              <p:cNvSpPr/>
              <p:nvPr/>
            </p:nvSpPr>
            <p:spPr>
              <a:xfrm rot="19001723">
                <a:off x="5030232" y="2317958"/>
                <a:ext cx="1097280" cy="914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9" name="Block Arc 8"/>
            <p:cNvSpPr/>
            <p:nvPr/>
          </p:nvSpPr>
          <p:spPr>
            <a:xfrm rot="5400000">
              <a:off x="3357561" y="3425826"/>
              <a:ext cx="5029202" cy="1905000"/>
            </a:xfrm>
            <a:prstGeom prst="blockArc">
              <a:avLst>
                <a:gd name="adj1" fmla="val 10613103"/>
                <a:gd name="adj2" fmla="val 29347"/>
                <a:gd name="adj3" fmla="val 0"/>
              </a:avLst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ZIFL CLADE</a:t>
              </a: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423862" y="8072418"/>
            <a:ext cx="67818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/>
                <a:cs typeface="Times New Roman"/>
              </a:rPr>
              <a:t>Figure S1: </a:t>
            </a:r>
            <a:r>
              <a:rPr lang="en-US" sz="1400" dirty="0">
                <a:latin typeface="Times New Roman"/>
                <a:cs typeface="Times New Roman"/>
              </a:rPr>
              <a:t>Neighbor-Joining (NJ) tree for MFS_1 family of proteins from </a:t>
            </a:r>
            <a:r>
              <a:rPr lang="en-US" sz="1400" i="1" dirty="0" err="1">
                <a:latin typeface="Times New Roman"/>
                <a:cs typeface="Times New Roman"/>
              </a:rPr>
              <a:t>Oryza</a:t>
            </a:r>
            <a:r>
              <a:rPr lang="en-US" sz="1400" i="1" dirty="0">
                <a:latin typeface="Times New Roman"/>
                <a:cs typeface="Times New Roman"/>
              </a:rPr>
              <a:t> sativa, </a:t>
            </a:r>
            <a:r>
              <a:rPr lang="en-US" sz="1400" i="1" dirty="0" err="1">
                <a:latin typeface="Times New Roman"/>
                <a:cs typeface="Times New Roman"/>
              </a:rPr>
              <a:t>Brachypodium</a:t>
            </a:r>
            <a:r>
              <a:rPr lang="en-US" sz="1400" i="1" dirty="0">
                <a:latin typeface="Times New Roman"/>
                <a:cs typeface="Times New Roman"/>
              </a:rPr>
              <a:t> </a:t>
            </a:r>
            <a:r>
              <a:rPr lang="en-US" sz="1400" i="1" dirty="0" err="1">
                <a:latin typeface="Times New Roman"/>
                <a:cs typeface="Times New Roman"/>
              </a:rPr>
              <a:t>distachyon</a:t>
            </a:r>
            <a:r>
              <a:rPr lang="en-US" sz="1400" i="1" dirty="0">
                <a:latin typeface="Times New Roman"/>
                <a:cs typeface="Times New Roman"/>
              </a:rPr>
              <a:t>, </a:t>
            </a:r>
            <a:r>
              <a:rPr lang="en-US" sz="1400" i="1" dirty="0" err="1">
                <a:latin typeface="Times New Roman"/>
                <a:cs typeface="Times New Roman"/>
              </a:rPr>
              <a:t>Zea</a:t>
            </a:r>
            <a:r>
              <a:rPr lang="en-US" sz="1400" i="1" dirty="0">
                <a:latin typeface="Times New Roman"/>
                <a:cs typeface="Times New Roman"/>
              </a:rPr>
              <a:t> mays</a:t>
            </a:r>
            <a:r>
              <a:rPr lang="en-US" sz="1400" dirty="0">
                <a:latin typeface="Times New Roman"/>
                <a:cs typeface="Times New Roman"/>
              </a:rPr>
              <a:t> and </a:t>
            </a:r>
            <a:r>
              <a:rPr lang="en-US" sz="1400" i="1" dirty="0" err="1">
                <a:latin typeface="Times New Roman"/>
                <a:cs typeface="Times New Roman"/>
              </a:rPr>
              <a:t>Triticum</a:t>
            </a:r>
            <a:r>
              <a:rPr lang="en-US" sz="1400" i="1" dirty="0">
                <a:latin typeface="Times New Roman"/>
                <a:cs typeface="Times New Roman"/>
              </a:rPr>
              <a:t> </a:t>
            </a:r>
            <a:r>
              <a:rPr lang="en-US" sz="1400" i="1" dirty="0" err="1">
                <a:latin typeface="Times New Roman"/>
                <a:cs typeface="Times New Roman"/>
              </a:rPr>
              <a:t>aestivum</a:t>
            </a:r>
            <a:r>
              <a:rPr lang="en-US" sz="1400" dirty="0">
                <a:latin typeface="Times New Roman"/>
                <a:cs typeface="Times New Roman"/>
              </a:rPr>
              <a:t> constructed using MEGA7.0 software with a bootstrap replicate value of 1000. The phylogenetic tree shows ZIFL proteins clustering into a distinct clade within the MFS family.</a:t>
            </a:r>
            <a:endParaRPr lang="en-IN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729372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0124" y="1281926"/>
            <a:ext cx="7648938" cy="5763399"/>
            <a:chOff x="90124" y="1281926"/>
            <a:chExt cx="7648938" cy="5763399"/>
          </a:xfrm>
        </p:grpSpPr>
        <p:grpSp>
          <p:nvGrpSpPr>
            <p:cNvPr id="4" name="Group 3"/>
            <p:cNvGrpSpPr/>
            <p:nvPr/>
          </p:nvGrpSpPr>
          <p:grpSpPr>
            <a:xfrm>
              <a:off x="90124" y="1600200"/>
              <a:ext cx="7361512" cy="5445125"/>
              <a:chOff x="113874" y="533400"/>
              <a:chExt cx="6527158" cy="4500839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57" r="91415"/>
              <a:stretch/>
            </p:blipFill>
            <p:spPr bwMode="auto">
              <a:xfrm>
                <a:off x="113874" y="533400"/>
                <a:ext cx="724326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251" t="957"/>
              <a:stretch/>
            </p:blipFill>
            <p:spPr bwMode="auto">
              <a:xfrm>
                <a:off x="2121724" y="538438"/>
                <a:ext cx="1666236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2"/>
              <a:stretch/>
            </p:blipFill>
            <p:spPr bwMode="auto">
              <a:xfrm>
                <a:off x="3955417" y="538438"/>
                <a:ext cx="2152018" cy="449076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261105" y="538439"/>
                <a:ext cx="379927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69" t="957" r="79152"/>
              <a:stretch/>
            </p:blipFill>
            <p:spPr bwMode="auto">
              <a:xfrm>
                <a:off x="995261" y="533400"/>
                <a:ext cx="1036049" cy="4495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119062" y="1281926"/>
              <a:ext cx="76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 Gene         MFS Signature  motif         Anti-porter motif                                 His-motif                            </a:t>
              </a:r>
              <a:r>
                <a:rPr lang="en-US" sz="1200" b="1" dirty="0" err="1">
                  <a:latin typeface="Times New Roman" pitchFamily="18" charset="0"/>
                  <a:cs typeface="Times New Roman" pitchFamily="18" charset="0"/>
                </a:rPr>
                <a:t>Cys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- motif</a:t>
              </a:r>
              <a:endParaRPr 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3827721" y="942044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498581" y="7502525"/>
            <a:ext cx="639104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for signature sequences specific for ZIFL proteins, namely, ZIFL MFS signature motif, the anti-porter signature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ntaining, His-containing signatures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71453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4">
            <a:extLst>
              <a:ext uri="{FF2B5EF4-FFF2-40B4-BE49-F238E27FC236}">
                <a16:creationId xmlns:a16="http://schemas.microsoft.com/office/drawing/2014/main" id="{D47B4554-0EF7-42A6-9D23-0A1808E078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331" y="5502877"/>
            <a:ext cx="6532661" cy="1169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S3:</a:t>
            </a:r>
            <a:r>
              <a:rPr lang="en-IN" sz="1400" b="1" dirty="0">
                <a:latin typeface="Times New Roman" pitchFamily="18" charset="0"/>
                <a:cs typeface="Times New Roman" pitchFamily="18" charset="0"/>
              </a:rPr>
              <a:t> Gene expression analysis of wheat ZIFL transcript during grain development. </a:t>
            </a:r>
            <a:r>
              <a:rPr lang="en-IN" sz="14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-PCR analysis of putative wheat TOM genes: </a:t>
            </a:r>
            <a:r>
              <a:rPr lang="en-IN" sz="1400" i="1" dirty="0">
                <a:latin typeface="Times New Roman" pitchFamily="18" charset="0"/>
                <a:cs typeface="Times New Roman" pitchFamily="18" charset="0"/>
              </a:rPr>
              <a:t>TaZIFL4.1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400" i="1" dirty="0">
                <a:latin typeface="Times New Roman" pitchFamily="18" charset="0"/>
                <a:cs typeface="Times New Roman" pitchFamily="18" charset="0"/>
              </a:rPr>
              <a:t>TaZIFL4.2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400" i="1" dirty="0">
                <a:latin typeface="Times New Roman" pitchFamily="18" charset="0"/>
                <a:cs typeface="Times New Roman" pitchFamily="18" charset="0"/>
              </a:rPr>
              <a:t>TaZIFL5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400" i="1" dirty="0">
                <a:latin typeface="Times New Roman" pitchFamily="18" charset="0"/>
                <a:cs typeface="Times New Roman" pitchFamily="18" charset="0"/>
              </a:rPr>
              <a:t>TaZIFL7.1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IN" sz="1400" i="1" dirty="0">
                <a:latin typeface="Times New Roman" pitchFamily="18" charset="0"/>
                <a:cs typeface="Times New Roman" pitchFamily="18" charset="0"/>
              </a:rPr>
              <a:t>TaZIFL7.2.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400" dirty="0" err="1">
                <a:latin typeface="Times New Roman" panose="02020603050405020304" pitchFamily="18" charset="0"/>
                <a:cs typeface="Times New Roman" pitchFamily="18" charset="0"/>
              </a:rPr>
              <a:t>qRT</a:t>
            </a:r>
            <a:r>
              <a:rPr lang="en-IN" sz="1400" dirty="0">
                <a:latin typeface="Times New Roman" panose="02020603050405020304" pitchFamily="18" charset="0"/>
                <a:cs typeface="Times New Roman" pitchFamily="18" charset="0"/>
              </a:rPr>
              <a:t>-PCR was performed on cDNA prepared from 2 µg of total RNA as mentioned in method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expression levels were calculated relative to 7 days after anthesis (DAA) tissue.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90BE4C9-F491-4701-AC50-D708E1255735}"/>
              </a:ext>
            </a:extLst>
          </p:cNvPr>
          <p:cNvGrpSpPr/>
          <p:nvPr/>
        </p:nvGrpSpPr>
        <p:grpSpPr>
          <a:xfrm>
            <a:off x="1170391" y="1787525"/>
            <a:ext cx="5364942" cy="3558560"/>
            <a:chOff x="1335284" y="187325"/>
            <a:chExt cx="5364942" cy="355856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18756D6-8D84-46E4-B0AD-47E3FA0B50E7}"/>
                </a:ext>
              </a:extLst>
            </p:cNvPr>
            <p:cNvSpPr txBox="1"/>
            <p:nvPr/>
          </p:nvSpPr>
          <p:spPr>
            <a:xfrm>
              <a:off x="2061678" y="3453497"/>
              <a:ext cx="9144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ZIFL4.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48F7FC7-7B6B-4BCC-82D8-D4775776820A}"/>
                </a:ext>
              </a:extLst>
            </p:cNvPr>
            <p:cNvSpPr txBox="1"/>
            <p:nvPr/>
          </p:nvSpPr>
          <p:spPr>
            <a:xfrm>
              <a:off x="2938462" y="3453497"/>
              <a:ext cx="9144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ZIFL4.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8F876C5-3A98-4D36-A727-A51CEA6CA289}"/>
                </a:ext>
              </a:extLst>
            </p:cNvPr>
            <p:cNvSpPr txBox="1"/>
            <p:nvPr/>
          </p:nvSpPr>
          <p:spPr>
            <a:xfrm>
              <a:off x="3918612" y="3453497"/>
              <a:ext cx="9144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ZIFL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FD4E9DA-E8AD-4BE6-A390-8E41E3844DCB}"/>
                </a:ext>
              </a:extLst>
            </p:cNvPr>
            <p:cNvSpPr txBox="1"/>
            <p:nvPr/>
          </p:nvSpPr>
          <p:spPr>
            <a:xfrm>
              <a:off x="4698322" y="3453497"/>
              <a:ext cx="9144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ZIFL7.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39EDEED-08FC-4922-92A2-A65AB574F25E}"/>
                </a:ext>
              </a:extLst>
            </p:cNvPr>
            <p:cNvSpPr txBox="1"/>
            <p:nvPr/>
          </p:nvSpPr>
          <p:spPr>
            <a:xfrm>
              <a:off x="5729787" y="3453497"/>
              <a:ext cx="9144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ZIFL7.2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9013DD9-9CB1-4C66-B1F4-036A98967D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8531"/>
            <a:stretch/>
          </p:blipFill>
          <p:spPr>
            <a:xfrm>
              <a:off x="1338262" y="187325"/>
              <a:ext cx="5361964" cy="3308663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9109875-DF9C-4C65-AF8E-1B7E00717FCA}"/>
                </a:ext>
              </a:extLst>
            </p:cNvPr>
            <p:cNvSpPr txBox="1"/>
            <p:nvPr/>
          </p:nvSpPr>
          <p:spPr>
            <a:xfrm rot="16200000">
              <a:off x="32148" y="1719061"/>
              <a:ext cx="29140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fold expression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33167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>
            <a:grpSpLocks/>
          </p:cNvGrpSpPr>
          <p:nvPr/>
        </p:nvGrpSpPr>
        <p:grpSpPr bwMode="auto">
          <a:xfrm>
            <a:off x="244503" y="1693606"/>
            <a:ext cx="6732559" cy="5486400"/>
            <a:chOff x="715962" y="762000"/>
            <a:chExt cx="8686800" cy="7086600"/>
          </a:xfrm>
        </p:grpSpPr>
        <p:pic>
          <p:nvPicPr>
            <p:cNvPr id="5" name="Picture 2" descr="C:\Users\Dell\Downloads\1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5962" y="762000"/>
              <a:ext cx="3708400" cy="7010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3" descr="C:\Users\Dell\Downloads\2 (1)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21162" y="762000"/>
              <a:ext cx="5181600" cy="7086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Rectangle 4"/>
          <p:cNvSpPr>
            <a:spLocks noChangeArrowheads="1"/>
          </p:cNvSpPr>
          <p:nvPr/>
        </p:nvSpPr>
        <p:spPr bwMode="auto">
          <a:xfrm>
            <a:off x="341312" y="7426325"/>
            <a:ext cx="6870699" cy="160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S4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Heat-map depicting relative differential expression of putative wheat ZIFL genes under various abiotic and biotic stresses: 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a.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 Heat maps of 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TaZIFL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genes under various abiotic (Phosphate starvation, Drought, Heat and Drought-Heat).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b.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Biotic stresses (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Fusarium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heat blight, 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Septoria</a:t>
            </a:r>
            <a:r>
              <a:rPr lang="en-US" sz="14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tritici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, stripe Rust and Powdery mildew). Heat-maps were generated using fold change values obtained after processing the expression values from 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expVIP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database. Green color represents down-regulation, black represents no change and red color represents up-regulation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91AAF9F-9AF9-4DD3-8659-C7420A152404}"/>
              </a:ext>
            </a:extLst>
          </p:cNvPr>
          <p:cNvSpPr/>
          <p:nvPr/>
        </p:nvSpPr>
        <p:spPr>
          <a:xfrm>
            <a:off x="384175" y="1177925"/>
            <a:ext cx="2648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a</a:t>
            </a:r>
            <a:endParaRPr lang="en-IN" sz="140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88E4D89-C052-4288-9AD0-FFEA0E787B57}"/>
              </a:ext>
            </a:extLst>
          </p:cNvPr>
          <p:cNvSpPr/>
          <p:nvPr/>
        </p:nvSpPr>
        <p:spPr>
          <a:xfrm>
            <a:off x="3243262" y="1171618"/>
            <a:ext cx="27443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</a:t>
            </a:r>
            <a:endParaRPr lang="en-IN" sz="1400" dirty="0"/>
          </a:p>
        </p:txBody>
      </p:sp>
    </p:spTree>
    <p:extLst>
      <p:ext uri="{BB962C8B-B14F-4D97-AF65-F5344CB8AC3E}">
        <p14:creationId xmlns:p14="http://schemas.microsoft.com/office/powerpoint/2010/main" val="37086401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A36D8225-2B7B-4ADB-8981-6B012C5C81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542" y="5026672"/>
            <a:ext cx="6886239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S5:</a:t>
            </a:r>
            <a:r>
              <a:rPr lang="en-IN" sz="1400" b="1" dirty="0">
                <a:latin typeface="Times New Roman" pitchFamily="18" charset="0"/>
                <a:cs typeface="Times New Roman" pitchFamily="18" charset="0"/>
              </a:rPr>
              <a:t> Gene expression analysis of wheat ZIFL transcript in root during Fe deficiency.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showing expression for putative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ZIFL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roots of control and 20 days post Fe deficiency. Heatmap was generated using MeV software based on the expression values calculated from NCBI Project ID PRJNA529036 [33]. Black to red 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ange depicts increasing expression, as shown by the 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r.</a:t>
            </a:r>
          </a:p>
          <a:p>
            <a:pPr algn="just"/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A72EAB3-F22C-483A-AF63-4D8AD1B2B6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944718" y="583855"/>
            <a:ext cx="2805478" cy="5670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2780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9</TotalTime>
  <Words>234</Words>
  <Application>Microsoft Office PowerPoint</Application>
  <PresentationFormat>Custom</PresentationFormat>
  <Paragraphs>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AK Pandey</cp:lastModifiedBy>
  <cp:revision>108</cp:revision>
  <dcterms:created xsi:type="dcterms:W3CDTF">2006-08-16T00:00:00Z</dcterms:created>
  <dcterms:modified xsi:type="dcterms:W3CDTF">2019-09-12T06:55:55Z</dcterms:modified>
</cp:coreProperties>
</file>